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s/slide29.xml" ContentType="application/vnd.openxmlformats-officedocument.presentationml.slide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slideshow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3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s/slide28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19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 advTm="1000">
    <p:fade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3B994-9DF7-4995-8E78-3FE1A9E6AC89}" type="datetimeFigureOut">
              <a:rPr lang="en-US" smtClean="0"/>
              <a:pPr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68AA1-E30D-43DA-9F0E-712FAADE58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 advTm="1000">
    <p:fade/>
  </p:transition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andr45\Desktop\Sri Lanka Population\Paper\Influenza and Other Respiratory Viruses\First Revision August 2013\LKA SA Week 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C:\Users\chandr45\Desktop\Sri Lanka Population\Paper\Influenza and Other Respiratory Viruses\First Revision August 2013\LKA SA Week 10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C:\Users\chandr45\Desktop\Sri Lanka Population\Paper\Influenza and Other Respiratory Viruses\First Revision August 2013\LKA SA Week 1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C:\Users\chandr45\Desktop\Sri Lanka Population\Paper\Influenza and Other Respiratory Viruses\First Revision August 2013\LKA SA Week 12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C:\Users\chandr45\Desktop\Sri Lanka Population\Paper\Influenza and Other Respiratory Viruses\First Revision August 2013\LKA SA Week 13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C:\Users\chandr45\Desktop\Sri Lanka Population\Paper\Influenza and Other Respiratory Viruses\First Revision August 2013\LKA SA Week 14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C:\Users\chandr45\Desktop\Sri Lanka Population\Paper\Influenza and Other Respiratory Viruses\First Revision August 2013\LKA SA Week 15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 descr="C:\Users\chandr45\Desktop\Sri Lanka Population\Paper\Influenza and Other Respiratory Viruses\First Revision August 2013\LKA SA Week 16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C:\Users\chandr45\Desktop\Sri Lanka Population\Paper\Influenza and Other Respiratory Viruses\First Revision August 2013\LKA SA Week 17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C:\Users\chandr45\Desktop\Sri Lanka Population\Paper\Influenza and Other Respiratory Viruses\First Revision August 2013\LKA SA Week 18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 descr="C:\Users\chandr45\Desktop\Sri Lanka Population\Paper\Influenza and Other Respiratory Viruses\First Revision August 2013\LKA SA Week 19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chandr45\Desktop\Sri Lanka Population\Paper\Influenza and Other Respiratory Viruses\First Revision August 2013\LKA SA Week 2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 descr="C:\Users\chandr45\Desktop\Sri Lanka Population\Paper\Influenza and Other Respiratory Viruses\First Revision August 2013\LKA SA Week 20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 descr="C:\Users\chandr45\Desktop\Sri Lanka Population\Paper\Influenza and Other Respiratory Viruses\First Revision August 2013\LKA SA Week 2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 descr="C:\Users\chandr45\Desktop\Sri Lanka Population\Paper\Influenza and Other Respiratory Viruses\First Revision August 2013\LKA SA Week 22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 descr="C:\Users\chandr45\Desktop\Sri Lanka Population\Paper\Influenza and Other Respiratory Viruses\First Revision August 2013\LKA SA Week 23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 descr="C:\Users\chandr45\Desktop\Sri Lanka Population\Paper\Influenza and Other Respiratory Viruses\First Revision August 2013\LKA SA Week 24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 descr="C:\Users\chandr45\Desktop\Sri Lanka Population\Paper\Influenza and Other Respiratory Viruses\First Revision August 2013\LKA SA Week 25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 descr="C:\Users\chandr45\Desktop\Sri Lanka Population\Paper\Influenza and Other Respiratory Viruses\First Revision August 2013\LKA SA Week 26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 descr="C:\Users\chandr45\Desktop\Sri Lanka Population\Paper\Influenza and Other Respiratory Viruses\First Revision August 2013\LKA SA Week 27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 descr="C:\Users\chandr45\Desktop\Sri Lanka Population\Paper\Influenza and Other Respiratory Viruses\First Revision August 2013\LKA SA Week 28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 descr="C:\Users\chandr45\Desktop\Sri Lanka Population\Paper\Influenza and Other Respiratory Viruses\First Revision August 2013\LKA SA Week 29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chandr45\Desktop\Sri Lanka Population\Paper\Influenza and Other Respiratory Viruses\First Revision August 2013\LKA SA Week 3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 descr="C:\Users\chandr45\Desktop\Sri Lanka Population\Paper\Influenza and Other Respiratory Viruses\First Revision August 2013\LKA SA Week 30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chandr45\Desktop\Sri Lanka Population\Paper\Influenza and Other Respiratory Viruses\First Revision August 2013\LKA SA Week 4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chandr45\Desktop\Sri Lanka Population\Paper\Influenza and Other Respiratory Viruses\First Revision August 2013\LKA SA Week 5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chandr45\Desktop\Sri Lanka Population\Paper\Influenza and Other Respiratory Viruses\First Revision August 2013\LKA SA Week 6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chandr45\Desktop\Sri Lanka Population\Paper\Influenza and Other Respiratory Viruses\First Revision August 2013\LKA SA Week 7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chandr45\Desktop\Sri Lanka Population\Paper\Influenza and Other Respiratory Viruses\First Revision August 2013\LKA SA Week 8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chandr45\Desktop\Sri Lanka Population\Paper\Influenza and Other Respiratory Viruses\First Revision August 2013\LKA SA Week 9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</p:spPr>
      </p:pic>
    </p:spTree>
  </p:cSld>
  <p:clrMapOvr>
    <a:masterClrMapping/>
  </p:clrMapOvr>
  <p:transition spd="med" advTm="1000">
    <p:fade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0</Words>
  <Application>Microsoft Office PowerPoint</Application>
  <PresentationFormat>On-screen Show (4:3)</PresentationFormat>
  <Paragraphs>0</Paragraphs>
  <Slides>3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  <vt:lpstr>Slide 29</vt:lpstr>
      <vt:lpstr>Slide 30</vt:lpstr>
    </vt:vector>
  </TitlesOfParts>
  <Company>International Studies and Program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andr45</dc:creator>
  <cp:lastModifiedBy>chandr45</cp:lastModifiedBy>
  <cp:revision>9</cp:revision>
  <dcterms:created xsi:type="dcterms:W3CDTF">2013-04-23T18:24:50Z</dcterms:created>
  <dcterms:modified xsi:type="dcterms:W3CDTF">2013-08-06T20:36:04Z</dcterms:modified>
</cp:coreProperties>
</file>